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50" y="2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8794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0941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49988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2816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249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3596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7741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672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5999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6815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8537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5E0A2-A40B-4BB8-9596-5CEE75391237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B70F9-6FBD-45BA-9184-1679420AF60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6538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703" y="1220583"/>
            <a:ext cx="4888992" cy="504901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71512" y="160133"/>
            <a:ext cx="414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2 – supplement 1 panel D</a:t>
            </a:r>
            <a:endParaRPr lang="en-AU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659467" y="3149600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2918178" y="3132667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936044" y="2824890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3296580" y="2824890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608666" y="4329289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2867377" y="4312356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885243" y="4004579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3245779" y="4004579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1743906" y="5171336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002617" y="5154403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020483" y="4846626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WT</a:t>
            </a:r>
            <a:endParaRPr lang="en-AU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381019" y="4846626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DKI</a:t>
            </a:r>
            <a:endParaRPr lang="en-AU" sz="1400" b="1" dirty="0"/>
          </a:p>
        </p:txBody>
      </p:sp>
      <p:sp>
        <p:nvSpPr>
          <p:cNvPr id="20" name="Right Brace 19"/>
          <p:cNvSpPr/>
          <p:nvPr/>
        </p:nvSpPr>
        <p:spPr>
          <a:xfrm>
            <a:off x="4255911" y="1862667"/>
            <a:ext cx="203200" cy="204328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1" name="TextBox 20"/>
          <p:cNvSpPr txBox="1"/>
          <p:nvPr/>
        </p:nvSpPr>
        <p:spPr>
          <a:xfrm>
            <a:off x="4874316" y="2699645"/>
            <a:ext cx="801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14 °C</a:t>
            </a:r>
            <a:endParaRPr lang="en-AU" dirty="0"/>
          </a:p>
        </p:txBody>
      </p:sp>
      <p:sp>
        <p:nvSpPr>
          <p:cNvPr id="22" name="Right Brace 21"/>
          <p:cNvSpPr/>
          <p:nvPr/>
        </p:nvSpPr>
        <p:spPr>
          <a:xfrm>
            <a:off x="4272841" y="4004579"/>
            <a:ext cx="186270" cy="168502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3" name="TextBox 22"/>
          <p:cNvSpPr txBox="1"/>
          <p:nvPr/>
        </p:nvSpPr>
        <p:spPr>
          <a:xfrm>
            <a:off x="4874316" y="4661960"/>
            <a:ext cx="801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28 °C</a:t>
            </a:r>
            <a:endParaRPr lang="en-AU" dirty="0"/>
          </a:p>
        </p:txBody>
      </p:sp>
      <p:sp>
        <p:nvSpPr>
          <p:cNvPr id="24" name="TextBox 23"/>
          <p:cNvSpPr txBox="1"/>
          <p:nvPr/>
        </p:nvSpPr>
        <p:spPr>
          <a:xfrm>
            <a:off x="4255911" y="255611"/>
            <a:ext cx="51761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UCP1 in brown fat lysates from wild type and ACC DKI mice exposed to indicated temperatures</a:t>
            </a:r>
            <a:endParaRPr lang="en-AU" dirty="0"/>
          </a:p>
        </p:txBody>
      </p:sp>
      <p:sp>
        <p:nvSpPr>
          <p:cNvPr id="25" name="TextBox 24"/>
          <p:cNvSpPr txBox="1"/>
          <p:nvPr/>
        </p:nvSpPr>
        <p:spPr>
          <a:xfrm>
            <a:off x="1685092" y="867652"/>
            <a:ext cx="3121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Short exposure</a:t>
            </a:r>
            <a:endParaRPr lang="en-AU" dirty="0"/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3690" y="1125418"/>
            <a:ext cx="4949952" cy="5561076"/>
          </a:xfrm>
          <a:prstGeom prst="rect">
            <a:avLst/>
          </a:prstGeom>
        </p:spPr>
      </p:pic>
      <p:sp>
        <p:nvSpPr>
          <p:cNvPr id="27" name="Right Brace 26"/>
          <p:cNvSpPr/>
          <p:nvPr/>
        </p:nvSpPr>
        <p:spPr>
          <a:xfrm flipH="1">
            <a:off x="5797516" y="1803245"/>
            <a:ext cx="203200" cy="204328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8" name="Right Brace 27"/>
          <p:cNvSpPr/>
          <p:nvPr/>
        </p:nvSpPr>
        <p:spPr>
          <a:xfrm flipH="1">
            <a:off x="5864514" y="4070010"/>
            <a:ext cx="186270" cy="168502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29" name="Straight Connector 28"/>
          <p:cNvCxnSpPr/>
          <p:nvPr/>
        </p:nvCxnSpPr>
        <p:spPr>
          <a:xfrm>
            <a:off x="7264850" y="1956556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8523561" y="1939623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7541427" y="1631846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8901963" y="1631846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7264850" y="2915135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8523561" y="2898202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7541427" y="2590425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36" name="TextBox 35"/>
          <p:cNvSpPr txBox="1"/>
          <p:nvPr/>
        </p:nvSpPr>
        <p:spPr>
          <a:xfrm>
            <a:off x="8901963" y="2590425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cxnSp>
        <p:nvCxnSpPr>
          <p:cNvPr id="37" name="Straight Connector 36"/>
          <p:cNvCxnSpPr/>
          <p:nvPr/>
        </p:nvCxnSpPr>
        <p:spPr>
          <a:xfrm>
            <a:off x="7264850" y="4071884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8523561" y="4054951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7541427" y="3747174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8901963" y="3747174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7606565" y="901942"/>
            <a:ext cx="3121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Long exposure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96300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71512" y="160133"/>
            <a:ext cx="414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2 – supplement 1 panel D</a:t>
            </a:r>
            <a:endParaRPr lang="en-AU" dirty="0"/>
          </a:p>
        </p:txBody>
      </p:sp>
      <p:sp>
        <p:nvSpPr>
          <p:cNvPr id="3" name="TextBox 2"/>
          <p:cNvSpPr txBox="1"/>
          <p:nvPr/>
        </p:nvSpPr>
        <p:spPr>
          <a:xfrm>
            <a:off x="4267199" y="529465"/>
            <a:ext cx="51761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Tubulin in brown fat lysates from wild type and ACC DKI mice exposed to indicated temperatures</a:t>
            </a:r>
            <a:endParaRPr lang="en-AU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3184" y="1366209"/>
            <a:ext cx="4242816" cy="5231892"/>
          </a:xfrm>
          <a:prstGeom prst="rect">
            <a:avLst/>
          </a:prstGeom>
        </p:spPr>
      </p:pic>
      <p:sp>
        <p:nvSpPr>
          <p:cNvPr id="5" name="Right Brace 4"/>
          <p:cNvSpPr/>
          <p:nvPr/>
        </p:nvSpPr>
        <p:spPr>
          <a:xfrm>
            <a:off x="5384800" y="2664178"/>
            <a:ext cx="203200" cy="145107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" name="TextBox 5"/>
          <p:cNvSpPr txBox="1"/>
          <p:nvPr/>
        </p:nvSpPr>
        <p:spPr>
          <a:xfrm>
            <a:off x="6003205" y="2908940"/>
            <a:ext cx="801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14 °C</a:t>
            </a:r>
            <a:endParaRPr lang="en-AU" dirty="0"/>
          </a:p>
        </p:txBody>
      </p:sp>
      <p:sp>
        <p:nvSpPr>
          <p:cNvPr id="7" name="Right Brace 6"/>
          <p:cNvSpPr/>
          <p:nvPr/>
        </p:nvSpPr>
        <p:spPr>
          <a:xfrm>
            <a:off x="5401730" y="4213874"/>
            <a:ext cx="186270" cy="168502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TextBox 7"/>
          <p:cNvSpPr txBox="1"/>
          <p:nvPr/>
        </p:nvSpPr>
        <p:spPr>
          <a:xfrm>
            <a:off x="6003205" y="4871255"/>
            <a:ext cx="801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28 °C</a:t>
            </a:r>
            <a:endParaRPr lang="en-AU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2682355" y="3445933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941066" y="3429000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958932" y="3121223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319468" y="3121223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2726039" y="4299611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984750" y="4282678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002616" y="3974901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4363152" y="3974901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2818834" y="5204310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077545" y="5187377"/>
            <a:ext cx="10837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095411" y="4879600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WT</a:t>
            </a:r>
            <a:endParaRPr lang="en-AU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4455947" y="4879600"/>
            <a:ext cx="530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DKI</a:t>
            </a:r>
            <a:endParaRPr lang="en-AU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2077156" y="2664178"/>
            <a:ext cx="225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1</a:t>
            </a:r>
            <a:endParaRPr lang="en-AU" dirty="0"/>
          </a:p>
        </p:txBody>
      </p:sp>
      <p:sp>
        <p:nvSpPr>
          <p:cNvPr id="25" name="TextBox 24"/>
          <p:cNvSpPr txBox="1"/>
          <p:nvPr/>
        </p:nvSpPr>
        <p:spPr>
          <a:xfrm>
            <a:off x="2077156" y="3530089"/>
            <a:ext cx="225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2</a:t>
            </a:r>
            <a:endParaRPr lang="en-AU" dirty="0"/>
          </a:p>
        </p:txBody>
      </p:sp>
      <p:sp>
        <p:nvSpPr>
          <p:cNvPr id="26" name="TextBox 25"/>
          <p:cNvSpPr txBox="1"/>
          <p:nvPr/>
        </p:nvSpPr>
        <p:spPr>
          <a:xfrm>
            <a:off x="2077156" y="4425167"/>
            <a:ext cx="225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3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110232" y="5204310"/>
            <a:ext cx="225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3534846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4</Words>
  <Application>Microsoft Office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niversity of Melbour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ra galic</dc:creator>
  <cp:lastModifiedBy>Sandra galic</cp:lastModifiedBy>
  <cp:revision>1</cp:revision>
  <dcterms:created xsi:type="dcterms:W3CDTF">2018-01-15T03:52:09Z</dcterms:created>
  <dcterms:modified xsi:type="dcterms:W3CDTF">2018-01-15T03:53:11Z</dcterms:modified>
</cp:coreProperties>
</file>